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>
        <p:scale>
          <a:sx n="168" d="100"/>
          <a:sy n="168" d="100"/>
        </p:scale>
        <p:origin x="3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A9B2036-D8C6-5F89-B1CA-D8964E9862E3}"/>
              </a:ext>
            </a:extLst>
          </p:cNvPr>
          <p:cNvSpPr txBox="1"/>
          <p:nvPr/>
        </p:nvSpPr>
        <p:spPr>
          <a:xfrm>
            <a:off x="620185" y="523879"/>
            <a:ext cx="15119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LR1/2 response: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White 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AD2F2B6-B38A-C5CC-6C65-8A23AD5D7BE9}"/>
              </a:ext>
            </a:extLst>
          </p:cNvPr>
          <p:cNvGrpSpPr>
            <a:grpSpLocks noChangeAspect="1"/>
          </p:cNvGrpSpPr>
          <p:nvPr/>
        </p:nvGrpSpPr>
        <p:grpSpPr>
          <a:xfrm>
            <a:off x="99171" y="644000"/>
            <a:ext cx="2333122" cy="1828800"/>
            <a:chOff x="4486929" y="2974353"/>
            <a:chExt cx="1723763" cy="135167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84B3A68-EB76-2001-39F6-45151B58CE8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/>
            <a:stretch/>
          </p:blipFill>
          <p:spPr>
            <a:xfrm>
              <a:off x="4486929" y="2974353"/>
              <a:ext cx="1723763" cy="135167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9A2DE7-151D-EAD7-B324-2027EA655AEE}"/>
                </a:ext>
              </a:extLst>
            </p:cNvPr>
            <p:cNvSpPr txBox="1"/>
            <p:nvPr/>
          </p:nvSpPr>
          <p:spPr>
            <a:xfrm>
              <a:off x="5598597" y="3944686"/>
              <a:ext cx="50847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=10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03EFD9F-2D52-B2B4-DD97-C1F47F2FD25B}"/>
                </a:ext>
              </a:extLst>
            </p:cNvPr>
            <p:cNvSpPr txBox="1"/>
            <p:nvPr/>
          </p:nvSpPr>
          <p:spPr>
            <a:xfrm>
              <a:off x="5124601" y="315841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BF9A3A0-C2F0-50EE-D56D-3E6CE8484C31}"/>
                </a:ext>
              </a:extLst>
            </p:cNvPr>
            <p:cNvSpPr txBox="1"/>
            <p:nvPr/>
          </p:nvSpPr>
          <p:spPr>
            <a:xfrm>
              <a:off x="5151972" y="390083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90EF842-0301-9D98-2F8B-44F0A4B47CB1}"/>
                </a:ext>
              </a:extLst>
            </p:cNvPr>
            <p:cNvSpPr txBox="1"/>
            <p:nvPr/>
          </p:nvSpPr>
          <p:spPr>
            <a:xfrm>
              <a:off x="5152034" y="3814196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F44A79F1-B95F-408C-5B85-62B78BFEC58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2233850" y="691992"/>
            <a:ext cx="2359741" cy="18288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40B9FA7-F248-6A0C-4048-5C22BB84CD04}"/>
              </a:ext>
            </a:extLst>
          </p:cNvPr>
          <p:cNvSpPr txBox="1"/>
          <p:nvPr/>
        </p:nvSpPr>
        <p:spPr>
          <a:xfrm>
            <a:off x="2733986" y="543727"/>
            <a:ext cx="16209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LR1/2 response: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/I or I/S 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B11687-76DC-5B35-0FB5-48CA4710A696}"/>
              </a:ext>
            </a:extLst>
          </p:cNvPr>
          <p:cNvSpPr txBox="1"/>
          <p:nvPr/>
        </p:nvSpPr>
        <p:spPr>
          <a:xfrm>
            <a:off x="4911203" y="543727"/>
            <a:ext cx="13708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LR1/2 response: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S/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C9BDFAA-ED9C-2E61-6A88-6AFE9CEE3024}"/>
              </a:ext>
            </a:extLst>
          </p:cNvPr>
          <p:cNvSpPr txBox="1"/>
          <p:nvPr/>
        </p:nvSpPr>
        <p:spPr>
          <a:xfrm>
            <a:off x="2254554" y="2533448"/>
            <a:ext cx="30479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Hazard Ratio -/+ 95% Confidence Interva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F6D7518-31D7-03C4-6A41-A253F3B94E27}"/>
              </a:ext>
            </a:extLst>
          </p:cNvPr>
          <p:cNvSpPr txBox="1"/>
          <p:nvPr/>
        </p:nvSpPr>
        <p:spPr>
          <a:xfrm>
            <a:off x="0" y="-21905"/>
            <a:ext cx="643364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 S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5DAF698-7041-C4E1-7625-0CCADF4DB94B}"/>
              </a:ext>
            </a:extLst>
          </p:cNvPr>
          <p:cNvSpPr txBox="1"/>
          <p:nvPr/>
        </p:nvSpPr>
        <p:spPr>
          <a:xfrm>
            <a:off x="116197" y="382847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3717A18-F940-4D66-C9B7-D7A64AC365F1}"/>
              </a:ext>
            </a:extLst>
          </p:cNvPr>
          <p:cNvSpPr txBox="1"/>
          <p:nvPr/>
        </p:nvSpPr>
        <p:spPr>
          <a:xfrm>
            <a:off x="2163283" y="382847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8769752-91C6-F3E2-6497-ABA2E24C46B4}"/>
              </a:ext>
            </a:extLst>
          </p:cNvPr>
          <p:cNvSpPr txBox="1"/>
          <p:nvPr/>
        </p:nvSpPr>
        <p:spPr>
          <a:xfrm>
            <a:off x="3493778" y="1535711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=67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48A567C0-2C5C-7AB5-6CDA-8E292DB5264D}"/>
              </a:ext>
            </a:extLst>
          </p:cNvPr>
          <p:cNvGrpSpPr>
            <a:grpSpLocks noChangeAspect="1"/>
          </p:cNvGrpSpPr>
          <p:nvPr/>
        </p:nvGrpSpPr>
        <p:grpSpPr>
          <a:xfrm>
            <a:off x="4412079" y="684421"/>
            <a:ext cx="2359740" cy="1828800"/>
            <a:chOff x="4304099" y="643932"/>
            <a:chExt cx="1623032" cy="1257849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0DB8E25-91F9-9BC3-FE5D-A72671941E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304099" y="643932"/>
              <a:ext cx="1623032" cy="1257849"/>
            </a:xfrm>
            <a:prstGeom prst="rect">
              <a:avLst/>
            </a:prstGeom>
          </p:spPr>
        </p:pic>
        <p:sp>
          <p:nvSpPr>
            <p:cNvPr id="15" name="Triangle 14">
              <a:extLst>
                <a:ext uri="{FF2B5EF4-FFF2-40B4-BE49-F238E27FC236}">
                  <a16:creationId xmlns:a16="http://schemas.microsoft.com/office/drawing/2014/main" id="{B119557E-1AB1-C050-B74A-5F31987E6B3A}"/>
                </a:ext>
              </a:extLst>
            </p:cNvPr>
            <p:cNvSpPr/>
            <p:nvPr/>
          </p:nvSpPr>
          <p:spPr>
            <a:xfrm rot="5400000">
              <a:off x="5672923" y="1048008"/>
              <a:ext cx="45719" cy="60669"/>
            </a:xfrm>
            <a:prstGeom prst="triangle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CD95DB5-F17E-2483-017E-757A4ACE697F}"/>
                </a:ext>
              </a:extLst>
            </p:cNvPr>
            <p:cNvSpPr txBox="1"/>
            <p:nvPr/>
          </p:nvSpPr>
          <p:spPr>
            <a:xfrm>
              <a:off x="4904273" y="1549396"/>
              <a:ext cx="258067" cy="2853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10E81F1-2030-F01C-86F7-4F4FBEB9A53D}"/>
                </a:ext>
              </a:extLst>
            </p:cNvPr>
            <p:cNvSpPr txBox="1"/>
            <p:nvPr/>
          </p:nvSpPr>
          <p:spPr>
            <a:xfrm>
              <a:off x="4916516" y="1477657"/>
              <a:ext cx="258067" cy="2853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12A3C41-ED75-4BB6-ED4A-6304A0D9CD4E}"/>
                </a:ext>
              </a:extLst>
            </p:cNvPr>
            <p:cNvSpPr txBox="1"/>
            <p:nvPr/>
          </p:nvSpPr>
          <p:spPr>
            <a:xfrm>
              <a:off x="4980537" y="1395259"/>
              <a:ext cx="258067" cy="2853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6D5FA5D-1A77-BD3E-30F8-3671B54C3E10}"/>
                </a:ext>
              </a:extLst>
            </p:cNvPr>
            <p:cNvSpPr txBox="1"/>
            <p:nvPr/>
          </p:nvSpPr>
          <p:spPr>
            <a:xfrm>
              <a:off x="5667978" y="1106568"/>
              <a:ext cx="258067" cy="2853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20" name="Triangle 19">
              <a:extLst>
                <a:ext uri="{FF2B5EF4-FFF2-40B4-BE49-F238E27FC236}">
                  <a16:creationId xmlns:a16="http://schemas.microsoft.com/office/drawing/2014/main" id="{112AEAB5-CCFC-EF4C-CBF9-9E33B0572C7A}"/>
                </a:ext>
              </a:extLst>
            </p:cNvPr>
            <p:cNvSpPr/>
            <p:nvPr/>
          </p:nvSpPr>
          <p:spPr>
            <a:xfrm rot="5400000">
              <a:off x="5672923" y="1200350"/>
              <a:ext cx="45719" cy="60669"/>
            </a:xfrm>
            <a:prstGeom prst="triangle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4DA461B-55F2-692E-B079-68980432A902}"/>
                </a:ext>
              </a:extLst>
            </p:cNvPr>
            <p:cNvSpPr txBox="1"/>
            <p:nvPr/>
          </p:nvSpPr>
          <p:spPr>
            <a:xfrm>
              <a:off x="4906945" y="1029746"/>
              <a:ext cx="258067" cy="2853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9CBFAC6-FA2D-D85B-E0AE-CC50DE9D62CC}"/>
                </a:ext>
              </a:extLst>
            </p:cNvPr>
            <p:cNvSpPr txBox="1"/>
            <p:nvPr/>
          </p:nvSpPr>
          <p:spPr>
            <a:xfrm>
              <a:off x="5394426" y="1526726"/>
              <a:ext cx="4443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=36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9219A635-408B-5360-8F2D-219E4EEEBC4A}"/>
              </a:ext>
            </a:extLst>
          </p:cNvPr>
          <p:cNvSpPr txBox="1"/>
          <p:nvPr/>
        </p:nvSpPr>
        <p:spPr>
          <a:xfrm>
            <a:off x="63661" y="2872875"/>
            <a:ext cx="673067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 (related to Figure 5)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zard ratios -/+ 95% confidence intervals from cytokine induction (fold Mock MFI) after TLR1/2 stimulation within indicated sub-cohorts from merged PRIME + KCI cohort analyses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PRIME cohort analyses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corresponding to Figures 5F-I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61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91</TotalTime>
  <Words>104</Words>
  <Application>Microsoft Macintosh PowerPoint</Application>
  <PresentationFormat>Letter Paper (8.5x11 in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41</cp:revision>
  <dcterms:created xsi:type="dcterms:W3CDTF">2024-05-14T01:47:53Z</dcterms:created>
  <dcterms:modified xsi:type="dcterms:W3CDTF">2024-09-16T19:59:36Z</dcterms:modified>
</cp:coreProperties>
</file>